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0" r:id="rId2"/>
    <p:sldId id="271" r:id="rId3"/>
    <p:sldId id="272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4" d="100"/>
          <a:sy n="64" d="100"/>
        </p:scale>
        <p:origin x="1364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B4CE1-DFFA-4E3A-83DF-9DB9FF5983D7}" type="datetimeFigureOut">
              <a:rPr kumimoji="1" lang="ja-JP" altLang="en-US" smtClean="0"/>
              <a:t>2023/9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6F2EA-0BED-4C46-ADC7-0FD45C185D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66320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B4CE1-DFFA-4E3A-83DF-9DB9FF5983D7}" type="datetimeFigureOut">
              <a:rPr kumimoji="1" lang="ja-JP" altLang="en-US" smtClean="0"/>
              <a:t>2023/9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6F2EA-0BED-4C46-ADC7-0FD45C185D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51419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B4CE1-DFFA-4E3A-83DF-9DB9FF5983D7}" type="datetimeFigureOut">
              <a:rPr kumimoji="1" lang="ja-JP" altLang="en-US" smtClean="0"/>
              <a:t>2023/9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6F2EA-0BED-4C46-ADC7-0FD45C185D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64579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B4CE1-DFFA-4E3A-83DF-9DB9FF5983D7}" type="datetimeFigureOut">
              <a:rPr kumimoji="1" lang="ja-JP" altLang="en-US" smtClean="0"/>
              <a:t>2023/9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6F2EA-0BED-4C46-ADC7-0FD45C185D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96980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B4CE1-DFFA-4E3A-83DF-9DB9FF5983D7}" type="datetimeFigureOut">
              <a:rPr kumimoji="1" lang="ja-JP" altLang="en-US" smtClean="0"/>
              <a:t>2023/9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6F2EA-0BED-4C46-ADC7-0FD45C185D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78488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B4CE1-DFFA-4E3A-83DF-9DB9FF5983D7}" type="datetimeFigureOut">
              <a:rPr kumimoji="1" lang="ja-JP" altLang="en-US" smtClean="0"/>
              <a:t>2023/9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6F2EA-0BED-4C46-ADC7-0FD45C185D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31192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B4CE1-DFFA-4E3A-83DF-9DB9FF5983D7}" type="datetimeFigureOut">
              <a:rPr kumimoji="1" lang="ja-JP" altLang="en-US" smtClean="0"/>
              <a:t>2023/9/1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6F2EA-0BED-4C46-ADC7-0FD45C185D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24059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B4CE1-DFFA-4E3A-83DF-9DB9FF5983D7}" type="datetimeFigureOut">
              <a:rPr kumimoji="1" lang="ja-JP" altLang="en-US" smtClean="0"/>
              <a:t>2023/9/1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6F2EA-0BED-4C46-ADC7-0FD45C185D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36293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B4CE1-DFFA-4E3A-83DF-9DB9FF5983D7}" type="datetimeFigureOut">
              <a:rPr kumimoji="1" lang="ja-JP" altLang="en-US" smtClean="0"/>
              <a:t>2023/9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6F2EA-0BED-4C46-ADC7-0FD45C185D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60301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B4CE1-DFFA-4E3A-83DF-9DB9FF5983D7}" type="datetimeFigureOut">
              <a:rPr kumimoji="1" lang="ja-JP" altLang="en-US" smtClean="0"/>
              <a:t>2023/9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6F2EA-0BED-4C46-ADC7-0FD45C185D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99503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B4CE1-DFFA-4E3A-83DF-9DB9FF5983D7}" type="datetimeFigureOut">
              <a:rPr kumimoji="1" lang="ja-JP" altLang="en-US" smtClean="0"/>
              <a:t>2023/9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06F2EA-0BED-4C46-ADC7-0FD45C185D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78761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0B4CE1-DFFA-4E3A-83DF-9DB9FF5983D7}" type="datetimeFigureOut">
              <a:rPr kumimoji="1" lang="ja-JP" altLang="en-US" smtClean="0"/>
              <a:t>2023/9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06F2EA-0BED-4C46-ADC7-0FD45C185D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7008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93A1B54C-4336-8B99-744A-847B48FA87C2}"/>
              </a:ext>
            </a:extLst>
          </p:cNvPr>
          <p:cNvSpPr txBox="1"/>
          <p:nvPr/>
        </p:nvSpPr>
        <p:spPr>
          <a:xfrm>
            <a:off x="3714697" y="144907"/>
            <a:ext cx="5068575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y name is “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okoro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”. </a:t>
            </a: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y owner, “Shinzo”, was once hospitalized for heart failure.</a:t>
            </a: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 don't want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nzo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 be admitted to hospital with worsening heart failure again. </a:t>
            </a: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 I'll tell you what all medical and care staffs in the community need to know.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78CAD9DE-6B37-6739-0A38-74542BEF5DD0}"/>
              </a:ext>
            </a:extLst>
          </p:cNvPr>
          <p:cNvSpPr txBox="1"/>
          <p:nvPr/>
        </p:nvSpPr>
        <p:spPr>
          <a:xfrm>
            <a:off x="3714698" y="1843342"/>
            <a:ext cx="5152466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course of heart failure can be likened to a hilly road with peaks and valleys.</a:t>
            </a: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ysical function declines with each repeated hospitalization for heart failure. When heart failure worsens, treatment gives the appearance of a temporary recovery.</a:t>
            </a: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wever, the condition does not recover to its pre-worsening state, and the deterioration in physical function makes life inconvenient and shortens the prognosis.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FAB7B747-5587-72F3-8802-1378123F14CF}"/>
              </a:ext>
            </a:extLst>
          </p:cNvPr>
          <p:cNvSpPr txBox="1"/>
          <p:nvPr/>
        </p:nvSpPr>
        <p:spPr>
          <a:xfrm>
            <a:off x="3714696" y="4280440"/>
            <a:ext cx="5068575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t's work together in the community to prevent worsening heart failure and support patients in order to extend their healthy life expectancy.</a:t>
            </a: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l medical and care staff in the community are member of the heart failure team.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t’s support the patients together!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2C2F5DDB-ED57-E688-D259-FFA082FAE370}"/>
              </a:ext>
            </a:extLst>
          </p:cNvPr>
          <p:cNvSpPr txBox="1"/>
          <p:nvPr/>
        </p:nvSpPr>
        <p:spPr>
          <a:xfrm>
            <a:off x="7074889" y="5485420"/>
            <a:ext cx="1954812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 time:1:49 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3" name="図 22">
            <a:extLst>
              <a:ext uri="{FF2B5EF4-FFF2-40B4-BE49-F238E27FC236}">
                <a16:creationId xmlns:a16="http://schemas.microsoft.com/office/drawing/2014/main" id="{9D97DAD0-B569-36B5-F17C-3A3AA2A342F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0728" y="110400"/>
            <a:ext cx="2702474" cy="1382696"/>
          </a:xfrm>
          <a:prstGeom prst="rect">
            <a:avLst/>
          </a:prstGeom>
        </p:spPr>
      </p:pic>
      <p:pic>
        <p:nvPicPr>
          <p:cNvPr id="25" name="図 24">
            <a:extLst>
              <a:ext uri="{FF2B5EF4-FFF2-40B4-BE49-F238E27FC236}">
                <a16:creationId xmlns:a16="http://schemas.microsoft.com/office/drawing/2014/main" id="{5490F4B8-E947-5456-4A0C-ED5CD2AC5C6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0727" y="4280440"/>
            <a:ext cx="2690299" cy="1485471"/>
          </a:xfrm>
          <a:prstGeom prst="rect">
            <a:avLst/>
          </a:prstGeom>
        </p:spPr>
      </p:pic>
      <p:pic>
        <p:nvPicPr>
          <p:cNvPr id="27" name="図 26">
            <a:extLst>
              <a:ext uri="{FF2B5EF4-FFF2-40B4-BE49-F238E27FC236}">
                <a16:creationId xmlns:a16="http://schemas.microsoft.com/office/drawing/2014/main" id="{0F82B7FE-A128-9331-02FD-ECE706A0EC9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0728" y="2270400"/>
            <a:ext cx="2690299" cy="1387280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01DD0DC-FF10-4709-BF18-D32263A2F89D}"/>
              </a:ext>
            </a:extLst>
          </p:cNvPr>
          <p:cNvSpPr txBox="1"/>
          <p:nvPr/>
        </p:nvSpPr>
        <p:spPr>
          <a:xfrm>
            <a:off x="8216057" y="6622892"/>
            <a:ext cx="1219201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1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426278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93A1B54C-4336-8B99-744A-847B48FA87C2}"/>
              </a:ext>
            </a:extLst>
          </p:cNvPr>
          <p:cNvSpPr txBox="1"/>
          <p:nvPr/>
        </p:nvSpPr>
        <p:spPr>
          <a:xfrm>
            <a:off x="3714697" y="287782"/>
            <a:ext cx="5068575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My name is “</a:t>
            </a:r>
            <a:r>
              <a:rPr kumimoji="0" lang="en-US" altLang="ja-JP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Kokoro</a:t>
            </a: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”. 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My owner, “Shinzo”, was once hospitalized for heart failure.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I don't want </a:t>
            </a:r>
            <a:r>
              <a:rPr kumimoji="0" lang="en-US" altLang="ja-JP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inzo</a:t>
            </a: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to be admitted to hospital with worsening heart failure again. 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o I'll tell you what all medical and care staffs in the community need to know.</a:t>
            </a:r>
            <a:endParaRPr kumimoji="0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78CAD9DE-6B37-6739-0A38-74542BEF5DD0}"/>
              </a:ext>
            </a:extLst>
          </p:cNvPr>
          <p:cNvSpPr txBox="1"/>
          <p:nvPr/>
        </p:nvSpPr>
        <p:spPr>
          <a:xfrm>
            <a:off x="3714698" y="1986217"/>
            <a:ext cx="5152466" cy="230832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It is important that you are aware of the signs of worsening heart failure, so that you don't miss them.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Three</a:t>
            </a: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points to check for worsening heart failure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The first point is weight gain.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Let’s measure patient’s weight every outpatient visit or care service use. 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econd point is swelling.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If you press down on patient’s foot for five to ten seconds and there are marks, you need to be careful. 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The third point is shortness of </a:t>
            </a: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breath. Check that patients have worsening of shortness of breath even </a:t>
            </a: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though they are just doing the same movements as before. 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Your awareness will save the patient.</a:t>
            </a:r>
            <a:endParaRPr kumimoji="0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FAB7B747-5587-72F3-8802-1378123F14CF}"/>
              </a:ext>
            </a:extLst>
          </p:cNvPr>
          <p:cNvSpPr txBox="1"/>
          <p:nvPr/>
        </p:nvSpPr>
        <p:spPr>
          <a:xfrm>
            <a:off x="3714697" y="4423315"/>
            <a:ext cx="5068574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Let's work together in the community to prevent worsening heart failure and support patients in order to extend their healthy life expectancy.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All medical and care staff in the community are member of the heart failure team.</a:t>
            </a:r>
            <a:r>
              <a:rPr kumimoji="0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　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Let’s support the patients together!</a:t>
            </a:r>
            <a:endParaRPr kumimoji="0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0D19E7EF-2EBD-374E-7256-2569312FE25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0728" y="253275"/>
            <a:ext cx="2702474" cy="1382696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E1493E87-9958-E31F-02B5-56DEAD5938C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0728" y="4422075"/>
            <a:ext cx="2690299" cy="1485471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964A012E-398C-F0C1-56CC-ECA642E78F3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0000" y="2413275"/>
            <a:ext cx="2702475" cy="1427320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FCF9D885-603A-9508-8629-87B9DE8ADA45}"/>
              </a:ext>
            </a:extLst>
          </p:cNvPr>
          <p:cNvSpPr txBox="1"/>
          <p:nvPr/>
        </p:nvSpPr>
        <p:spPr>
          <a:xfrm>
            <a:off x="8216057" y="6622892"/>
            <a:ext cx="1219201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2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E293053-CDFE-F2EA-3891-229B03925BEE}"/>
              </a:ext>
            </a:extLst>
          </p:cNvPr>
          <p:cNvSpPr txBox="1"/>
          <p:nvPr/>
        </p:nvSpPr>
        <p:spPr>
          <a:xfrm>
            <a:off x="7074889" y="5628295"/>
            <a:ext cx="1954812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 time:2:00 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376222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93A1B54C-4336-8B99-744A-847B48FA87C2}"/>
              </a:ext>
            </a:extLst>
          </p:cNvPr>
          <p:cNvSpPr txBox="1"/>
          <p:nvPr/>
        </p:nvSpPr>
        <p:spPr>
          <a:xfrm>
            <a:off x="3714697" y="259207"/>
            <a:ext cx="5068575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My name is “</a:t>
            </a:r>
            <a:r>
              <a:rPr kumimoji="0" lang="en-US" altLang="ja-JP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Kokoro</a:t>
            </a: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”. 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My owner, “Shinzo”, was once hospitalized for heart failure.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I don't want </a:t>
            </a:r>
            <a:r>
              <a:rPr kumimoji="0" lang="en-US" altLang="ja-JP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inzo</a:t>
            </a: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to be admitted to hospital with worsening heart failure again. 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o I'll tell you what all medical and care staffs in the community need to know.</a:t>
            </a:r>
            <a:endParaRPr kumimoji="0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78CAD9DE-6B37-6739-0A38-74542BEF5DD0}"/>
              </a:ext>
            </a:extLst>
          </p:cNvPr>
          <p:cNvSpPr txBox="1"/>
          <p:nvPr/>
        </p:nvSpPr>
        <p:spPr>
          <a:xfrm>
            <a:off x="3714698" y="1957642"/>
            <a:ext cx="5152466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Let’s use the heart </a:t>
            </a:r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f</a:t>
            </a:r>
            <a:r>
              <a:rPr kumimoji="0" lang="en-US" altLang="ja-JP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ailure</a:t>
            </a: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handbook to share the patient's condition in the community.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Ask patients to write down their blood pressure, weight and symptoms in a </a:t>
            </a:r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hand</a:t>
            </a: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book, and carry it when visiting outpatient clinic  or care service facilities.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Medical and care staffs </a:t>
            </a:r>
            <a:r>
              <a:rPr lang="en-US" altLang="ja-JP" sz="12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c</a:t>
            </a: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heck the handbook not to miss the worsening heart failure. If there is weight gain, worsening breathlessness, or worsening swelling, who</a:t>
            </a:r>
            <a:r>
              <a:rPr lang="en-US" altLang="ja-JP" sz="12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ever</a:t>
            </a: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notice them should consult </a:t>
            </a: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the family doctor.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The heart failure handbook has a contact note section, so share information in the community.</a:t>
            </a:r>
            <a:endParaRPr kumimoji="0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FAB7B747-5587-72F3-8802-1378123F14CF}"/>
              </a:ext>
            </a:extLst>
          </p:cNvPr>
          <p:cNvSpPr txBox="1"/>
          <p:nvPr/>
        </p:nvSpPr>
        <p:spPr>
          <a:xfrm>
            <a:off x="3714697" y="4394740"/>
            <a:ext cx="5068574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Let's work together in the community to prevent worsening heart failure and support patients in order to extend their healthy life expectancy.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All medical and care staff in the community are member of the heart failure team.</a:t>
            </a:r>
            <a:r>
              <a:rPr kumimoji="0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　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Let’s support the patients together!</a:t>
            </a:r>
            <a:endParaRPr kumimoji="0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pic>
        <p:nvPicPr>
          <p:cNvPr id="9" name="図 8">
            <a:extLst>
              <a:ext uri="{FF2B5EF4-FFF2-40B4-BE49-F238E27FC236}">
                <a16:creationId xmlns:a16="http://schemas.microsoft.com/office/drawing/2014/main" id="{7DAE2008-DE74-A4B4-8CB9-79FFE1ECD8F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4484" y="2384700"/>
            <a:ext cx="2680096" cy="1382696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B9B4BC63-DC66-BB8C-540C-148ECB1E7EB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0728" y="224700"/>
            <a:ext cx="2702474" cy="1382696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741413B1-940F-BE91-400A-0CCB9B29C16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04484" y="4393500"/>
            <a:ext cx="2690299" cy="1485471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0C477AD-24DF-E849-2BB9-98F3FDC310B5}"/>
              </a:ext>
            </a:extLst>
          </p:cNvPr>
          <p:cNvSpPr txBox="1"/>
          <p:nvPr/>
        </p:nvSpPr>
        <p:spPr>
          <a:xfrm>
            <a:off x="8216057" y="6622892"/>
            <a:ext cx="1219201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3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AAA167A2-CD1D-ACD1-B7D7-FB7B4DAA2A05}"/>
              </a:ext>
            </a:extLst>
          </p:cNvPr>
          <p:cNvSpPr txBox="1"/>
          <p:nvPr/>
        </p:nvSpPr>
        <p:spPr>
          <a:xfrm>
            <a:off x="7074889" y="5599720"/>
            <a:ext cx="1954812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 time:1.38 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442450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78</TotalTime>
  <Words>584</Words>
  <Application>Microsoft Office PowerPoint</Application>
  <PresentationFormat>画面に合わせる (4:3)</PresentationFormat>
  <Paragraphs>42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衣笠 良治</dc:creator>
  <cp:lastModifiedBy>良治 衣笠</cp:lastModifiedBy>
  <cp:revision>32</cp:revision>
  <cp:lastPrinted>2022-10-24T06:44:44Z</cp:lastPrinted>
  <dcterms:created xsi:type="dcterms:W3CDTF">2022-10-04T12:42:28Z</dcterms:created>
  <dcterms:modified xsi:type="dcterms:W3CDTF">2023-09-14T03:19:43Z</dcterms:modified>
</cp:coreProperties>
</file>